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  <p:sldId id="259" r:id="rId5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73360D9-1440-C849-873F-20C8D43397CA}" v="3" dt="2019-09-22T13:19:33.9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4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5B990-EC8C-4B54-868C-A03CFB8FC4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AC2569-26EE-4F6A-91B9-26ACD48E6E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336B4-C545-4E5A-9754-91DA2E800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E55B4A-0572-48AA-9B4A-F8DACF6BA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ACEE94-FECF-4EA1-93F8-098EF7D80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133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EB499-C27D-417B-8B2D-EC325AE06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09D4D-5EBC-45AE-81BE-7E36AD1EDB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74B22-06BE-47D3-8B2B-4A88F2CF5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F4783F-A6B3-4411-A4BF-E98C443A9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2E1589-8AA5-4020-A26D-A0D3C099B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324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CB7378-3E26-460D-A9B6-CCCFC8FEE6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41F385-BAFF-432A-AC26-0627459E57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3C3AF-B110-4ABF-99B3-36A8864A6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8747C5-0C8E-4FEF-8ED9-31CFBC926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3FA9DD-1454-4767-9AFA-06EE9DC4D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960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A6D07A-8201-4185-9D7F-BFA7B1E75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DB4BE9-9C9D-4CD6-9216-BBE6683AAE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19FD-850D-4786-BE9F-436F77093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CC0A0C-392F-4F44-B312-E310DBA03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195D3-1455-4936-8A21-F04E462D6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0789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94DD5D-4966-4ED8-B580-9E3F49921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771158-E225-42AC-8907-5F5D42D156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EEA49-0B09-4E02-9F83-EFD1298F7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CE26E-FB40-4815-81FA-8ABA0E869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284905-CE92-4094-AB7F-711C1B4C7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778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A80122-D298-48B8-A91D-7187662E8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97C421-921A-4342-9F2D-DD4B42BB91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C7416E-C3D5-41CF-9A6E-D294A7FC33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15E37D-60D0-4809-B037-C1D181767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F959A3-CA39-45F8-A668-2E5EACF7F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DA17C7-5582-4997-A4BC-2A22B330C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9686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3D26F-342D-485B-B93F-A09A8A0BB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CEB972-CCB2-483D-A1AF-E9F860022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52ACEE-BE7A-4980-8368-9B9A80B548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8344C5-ADC7-4D71-840A-93B73092AE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667D9E-1112-451F-9A5E-788CBAF9F1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2B2FEE-79AE-4370-BB3E-0C29C2720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A1EBE4-B692-4EF4-9EB2-2462D7E85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7A4506-988F-4E3B-99D2-B10AB376D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69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542B0-0FEA-4797-8ED0-084118B8E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E83215-449D-442D-AA52-19906705D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2C9091-16A6-4546-9F2F-41C8343EA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952151-12B4-4080-87FF-21310A198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674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951487-A748-4CE4-B717-216C79920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D295FB-CB96-4494-8C56-01E1707FE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A32E17F-7BBA-4E6F-9A2C-AB15D8A7B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2127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78E27-CB78-449B-8370-C33A1EE3D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1BCFC7-DA44-4C86-BCBC-973C797019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FBA2A2-F914-49FB-A12E-F1C11E0A6A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C1D079-06C4-4051-A6C8-C67CDDA0E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7CB27D-F5F9-42BE-8AFB-0394F7941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253EC8-139C-4F9A-968A-B0781CF40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504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5D191-B1FF-4427-A965-0B305D036C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D462F5-3EE9-4654-836A-7732E6B089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095FFA-24F6-485B-9304-3009F25B9B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7AB129-C151-4B74-A22D-8418F5AA1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2CA734-074C-4EA8-8DD0-38BA92E9B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9DCA89-7804-4A92-B1B7-CFE2A7299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4075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8B8091-70A8-4E46-917C-16419A3C94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071FB2-83DA-4965-AFA5-9237941A9D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219473-50E5-4E79-80DD-6F52FB61A3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1A2B4-AE70-47C4-8E3A-99FF5FC335C6}" type="datetimeFigureOut">
              <a:rPr lang="en-GB" smtClean="0"/>
              <a:t>04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01702B-27E8-4D9A-B08F-7D7CA55789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924A4-E7A5-408C-B516-E40EB34631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41C8E-A401-4804-907E-E998A774A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830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sv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A6E39468-14A0-4F4A-95E9-679B5EC335F6}"/>
              </a:ext>
            </a:extLst>
          </p:cNvPr>
          <p:cNvSpPr txBox="1"/>
          <p:nvPr/>
        </p:nvSpPr>
        <p:spPr>
          <a:xfrm>
            <a:off x="10292539" y="151752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86C656-B9AF-471E-B598-43235F2FC7D1}"/>
              </a:ext>
            </a:extLst>
          </p:cNvPr>
          <p:cNvSpPr txBox="1"/>
          <p:nvPr/>
        </p:nvSpPr>
        <p:spPr>
          <a:xfrm>
            <a:off x="9810841" y="151335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9AC652-836F-4C4B-82A7-9FD427C19BFB}"/>
              </a:ext>
            </a:extLst>
          </p:cNvPr>
          <p:cNvSpPr txBox="1"/>
          <p:nvPr/>
        </p:nvSpPr>
        <p:spPr>
          <a:xfrm>
            <a:off x="8203122" y="1506368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4B725A8-C9ED-4DF7-A805-783963214B2A}"/>
              </a:ext>
            </a:extLst>
          </p:cNvPr>
          <p:cNvSpPr txBox="1"/>
          <p:nvPr/>
        </p:nvSpPr>
        <p:spPr>
          <a:xfrm>
            <a:off x="7552170" y="1528053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AC0627E-DDEE-4FDF-9322-B3D0C1CA8FE5}"/>
              </a:ext>
            </a:extLst>
          </p:cNvPr>
          <p:cNvSpPr txBox="1"/>
          <p:nvPr/>
        </p:nvSpPr>
        <p:spPr>
          <a:xfrm>
            <a:off x="7146270" y="1520339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C160293-AE8D-4C6B-A4FD-B96C81ADA9B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7436" y="1616711"/>
            <a:ext cx="4218565" cy="3970654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232D8AE-A75D-47EC-ACD1-E93A9ECCF8BD}"/>
              </a:ext>
            </a:extLst>
          </p:cNvPr>
          <p:cNvCxnSpPr>
            <a:cxnSpLocks/>
          </p:cNvCxnSpPr>
          <p:nvPr/>
        </p:nvCxnSpPr>
        <p:spPr>
          <a:xfrm flipV="1">
            <a:off x="5119688" y="1903643"/>
            <a:ext cx="2018118" cy="961332"/>
          </a:xfrm>
          <a:prstGeom prst="straightConnector1">
            <a:avLst/>
          </a:prstGeom>
          <a:ln w="9525" cap="flat" cmpd="sng" algn="ctr">
            <a:solidFill>
              <a:srgbClr val="FF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A31F356-9671-4D0D-AAFE-9AA09AA13C25}"/>
              </a:ext>
            </a:extLst>
          </p:cNvPr>
          <p:cNvCxnSpPr>
            <a:cxnSpLocks/>
          </p:cNvCxnSpPr>
          <p:nvPr/>
        </p:nvCxnSpPr>
        <p:spPr>
          <a:xfrm>
            <a:off x="5119688" y="3224575"/>
            <a:ext cx="1977673" cy="0"/>
          </a:xfrm>
          <a:prstGeom prst="straightConnector1">
            <a:avLst/>
          </a:prstGeom>
          <a:ln w="9525" cap="flat" cmpd="sng" algn="ctr">
            <a:solidFill>
              <a:srgbClr val="FF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41A8D18-78B0-4CD7-8D65-301474B8F6F2}"/>
              </a:ext>
            </a:extLst>
          </p:cNvPr>
          <p:cNvCxnSpPr>
            <a:cxnSpLocks/>
          </p:cNvCxnSpPr>
          <p:nvPr/>
        </p:nvCxnSpPr>
        <p:spPr>
          <a:xfrm flipV="1">
            <a:off x="6402104" y="3905525"/>
            <a:ext cx="752344" cy="57136"/>
          </a:xfrm>
          <a:prstGeom prst="straightConnector1">
            <a:avLst/>
          </a:prstGeom>
          <a:ln w="9525" cap="flat" cmpd="sng" algn="ctr">
            <a:solidFill>
              <a:srgbClr val="FF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515A1AB-4DAB-42B8-B4B9-BA8E4A7E3FE9}"/>
              </a:ext>
            </a:extLst>
          </p:cNvPr>
          <p:cNvCxnSpPr>
            <a:cxnSpLocks/>
          </p:cNvCxnSpPr>
          <p:nvPr/>
        </p:nvCxnSpPr>
        <p:spPr>
          <a:xfrm>
            <a:off x="6416779" y="4173932"/>
            <a:ext cx="752580" cy="491788"/>
          </a:xfrm>
          <a:prstGeom prst="straightConnector1">
            <a:avLst/>
          </a:prstGeom>
          <a:ln w="9525" cap="flat" cmpd="sng" algn="ctr">
            <a:solidFill>
              <a:srgbClr val="FF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E217DA53-BB24-4845-A379-2A168A451F7D}"/>
              </a:ext>
            </a:extLst>
          </p:cNvPr>
          <p:cNvSpPr/>
          <p:nvPr/>
        </p:nvSpPr>
        <p:spPr>
          <a:xfrm>
            <a:off x="83483" y="87449"/>
            <a:ext cx="1059709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1: Field set up location </a:t>
            </a:r>
            <a:r>
              <a:rPr lang="en-US" alt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redepeel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sandy soils). Samples were taken from field 27.2b, 27.1a and 34.2a. The six sampled sub-plots are indicated (S1-S6) with green dotted lines.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27CA45C-EDC2-4983-9100-D56D68D35A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61046" y="1889671"/>
            <a:ext cx="4533208" cy="135967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9793004-C1E3-4868-B4C3-FD2D55C0B98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3033"/>
          <a:stretch/>
        </p:blipFill>
        <p:spPr>
          <a:xfrm>
            <a:off x="7184210" y="3865839"/>
            <a:ext cx="3309561" cy="80876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0C2B018-9277-42C5-A50C-F3DE6AE758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540"/>
          <a:stretch/>
        </p:blipFill>
        <p:spPr>
          <a:xfrm>
            <a:off x="10487846" y="3865839"/>
            <a:ext cx="459358" cy="80876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9A9F677-A8D9-4EBB-9BAB-F21A03FE639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923" t="85222"/>
          <a:stretch/>
        </p:blipFill>
        <p:spPr>
          <a:xfrm>
            <a:off x="7169434" y="3304603"/>
            <a:ext cx="4458050" cy="2012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783AB42-3CBA-4676-973C-46589DAB921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571" t="77684" r="-5571"/>
          <a:stretch/>
        </p:blipFill>
        <p:spPr>
          <a:xfrm>
            <a:off x="7184210" y="4809462"/>
            <a:ext cx="3970054" cy="201240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295ACDA3-31CB-4E96-B652-AC9BD53D0FA3}"/>
              </a:ext>
            </a:extLst>
          </p:cNvPr>
          <p:cNvGrpSpPr/>
          <p:nvPr/>
        </p:nvGrpSpPr>
        <p:grpSpPr>
          <a:xfrm>
            <a:off x="1701304" y="4463097"/>
            <a:ext cx="888213" cy="1124268"/>
            <a:chOff x="7120592" y="5170261"/>
            <a:chExt cx="888213" cy="1124268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18914EB-036E-4A84-8410-5D389C498B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77669"/>
            <a:stretch/>
          </p:blipFill>
          <p:spPr>
            <a:xfrm>
              <a:off x="7169434" y="5204662"/>
              <a:ext cx="732995" cy="1089867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0CF5872-1909-4301-86B1-00C660E774C3}"/>
                </a:ext>
              </a:extLst>
            </p:cNvPr>
            <p:cNvSpPr/>
            <p:nvPr/>
          </p:nvSpPr>
          <p:spPr>
            <a:xfrm>
              <a:off x="7140682" y="5170261"/>
              <a:ext cx="761747" cy="4154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Compost </a:t>
              </a:r>
            </a:p>
            <a:p>
              <a:pPr algn="ctr"/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plots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53063AAB-C358-4CC5-9F83-24D817754B4D}"/>
                </a:ext>
              </a:extLst>
            </p:cNvPr>
            <p:cNvSpPr/>
            <p:nvPr/>
          </p:nvSpPr>
          <p:spPr>
            <a:xfrm>
              <a:off x="7221228" y="5641903"/>
              <a:ext cx="6030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Tillage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66834A5-BA01-4666-A8D2-6270D94466DA}"/>
                </a:ext>
              </a:extLst>
            </p:cNvPr>
            <p:cNvSpPr/>
            <p:nvPr/>
          </p:nvSpPr>
          <p:spPr>
            <a:xfrm>
              <a:off x="7120592" y="5981831"/>
              <a:ext cx="888213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050" dirty="0">
                  <a:latin typeface="arialody)"/>
                </a:rPr>
                <a:t>No-tillage</a:t>
              </a:r>
            </a:p>
          </p:txBody>
        </p:sp>
      </p:grpSp>
      <p:sp>
        <p:nvSpPr>
          <p:cNvPr id="22" name="Rectangle 21">
            <a:extLst>
              <a:ext uri="{FF2B5EF4-FFF2-40B4-BE49-F238E27FC236}">
                <a16:creationId xmlns:a16="http://schemas.microsoft.com/office/drawing/2014/main" id="{2CC1576C-1697-418A-A9E2-F2138BC95D5E}"/>
              </a:ext>
            </a:extLst>
          </p:cNvPr>
          <p:cNvSpPr/>
          <p:nvPr/>
        </p:nvSpPr>
        <p:spPr>
          <a:xfrm>
            <a:off x="9116935" y="1546559"/>
            <a:ext cx="372269" cy="1738366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5B1BA06-4E84-4613-948E-F057BD0B9AFD}"/>
              </a:ext>
            </a:extLst>
          </p:cNvPr>
          <p:cNvSpPr/>
          <p:nvPr/>
        </p:nvSpPr>
        <p:spPr>
          <a:xfrm>
            <a:off x="9800024" y="1546559"/>
            <a:ext cx="372269" cy="1735964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496F81B-91ED-48AD-8B61-29B337C720CF}"/>
              </a:ext>
            </a:extLst>
          </p:cNvPr>
          <p:cNvSpPr/>
          <p:nvPr/>
        </p:nvSpPr>
        <p:spPr>
          <a:xfrm>
            <a:off x="10310147" y="1544157"/>
            <a:ext cx="372269" cy="1738366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88827FA-58E4-47E7-BAFF-CC49A527BD32}"/>
              </a:ext>
            </a:extLst>
          </p:cNvPr>
          <p:cNvSpPr txBox="1"/>
          <p:nvPr/>
        </p:nvSpPr>
        <p:spPr>
          <a:xfrm>
            <a:off x="9119871" y="1520339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490614-FCAD-4BC7-9B2D-B3C708522BFF}"/>
              </a:ext>
            </a:extLst>
          </p:cNvPr>
          <p:cNvSpPr txBox="1"/>
          <p:nvPr/>
        </p:nvSpPr>
        <p:spPr>
          <a:xfrm>
            <a:off x="5194320" y="5499195"/>
            <a:ext cx="127932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Organic plots</a:t>
            </a:r>
          </a:p>
          <a:p>
            <a:r>
              <a:rPr lang="en-GB" sz="1100" dirty="0"/>
              <a:t>Or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0648A24-A657-4D6C-956A-5CD6B48A21AC}"/>
              </a:ext>
            </a:extLst>
          </p:cNvPr>
          <p:cNvSpPr txBox="1"/>
          <p:nvPr/>
        </p:nvSpPr>
        <p:spPr>
          <a:xfrm>
            <a:off x="3119590" y="5500384"/>
            <a:ext cx="1740285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onventional plots</a:t>
            </a:r>
          </a:p>
          <a:p>
            <a:r>
              <a:rPr lang="en-GB" sz="1100" dirty="0"/>
              <a:t>.1 = </a:t>
            </a:r>
            <a:r>
              <a:rPr lang="en-GB" sz="1100" dirty="0" err="1"/>
              <a:t>ConSlu</a:t>
            </a:r>
            <a:endParaRPr lang="en-GB" sz="1100" dirty="0"/>
          </a:p>
          <a:p>
            <a:r>
              <a:rPr lang="en-GB" sz="1100" dirty="0"/>
              <a:t>.2 = ConMi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AECF6CD-04B0-4629-8B28-3298999D5792}"/>
              </a:ext>
            </a:extLst>
          </p:cNvPr>
          <p:cNvSpPr txBox="1"/>
          <p:nvPr/>
        </p:nvSpPr>
        <p:spPr>
          <a:xfrm>
            <a:off x="10033279" y="356567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6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C588092-C9B5-4801-985E-2D6C29D6FF24}"/>
              </a:ext>
            </a:extLst>
          </p:cNvPr>
          <p:cNvSpPr txBox="1"/>
          <p:nvPr/>
        </p:nvSpPr>
        <p:spPr>
          <a:xfrm>
            <a:off x="9541828" y="3558882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961FAC3-FA45-4689-93E6-AA12B545C2A8}"/>
              </a:ext>
            </a:extLst>
          </p:cNvPr>
          <p:cNvSpPr txBox="1"/>
          <p:nvPr/>
        </p:nvSpPr>
        <p:spPr>
          <a:xfrm>
            <a:off x="7575334" y="356498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9940F44-C704-49EB-90AD-FF7F476E27B6}"/>
              </a:ext>
            </a:extLst>
          </p:cNvPr>
          <p:cNvSpPr txBox="1"/>
          <p:nvPr/>
        </p:nvSpPr>
        <p:spPr>
          <a:xfrm>
            <a:off x="7169434" y="357250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1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C43B3F9-D399-42AF-AD14-E32B4247F7C9}"/>
              </a:ext>
            </a:extLst>
          </p:cNvPr>
          <p:cNvSpPr/>
          <p:nvPr/>
        </p:nvSpPr>
        <p:spPr>
          <a:xfrm>
            <a:off x="8166307" y="3596855"/>
            <a:ext cx="372269" cy="1107784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5CD3CAF-3985-4F5B-848A-9D7198C932C8}"/>
              </a:ext>
            </a:extLst>
          </p:cNvPr>
          <p:cNvSpPr/>
          <p:nvPr/>
        </p:nvSpPr>
        <p:spPr>
          <a:xfrm>
            <a:off x="8925354" y="3596855"/>
            <a:ext cx="372269" cy="1106590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2EFF302-916E-430F-B9C2-806FF0F2A795}"/>
              </a:ext>
            </a:extLst>
          </p:cNvPr>
          <p:cNvSpPr/>
          <p:nvPr/>
        </p:nvSpPr>
        <p:spPr>
          <a:xfrm>
            <a:off x="9531011" y="3596855"/>
            <a:ext cx="372269" cy="1106313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23A5419-17F6-4B4E-A23A-A9FA84FD475A}"/>
              </a:ext>
            </a:extLst>
          </p:cNvPr>
          <p:cNvSpPr/>
          <p:nvPr/>
        </p:nvSpPr>
        <p:spPr>
          <a:xfrm>
            <a:off x="10018308" y="3596856"/>
            <a:ext cx="372269" cy="111261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8A42A5E-26F5-40FF-BFEE-F8C00CBA00F1}"/>
              </a:ext>
            </a:extLst>
          </p:cNvPr>
          <p:cNvSpPr txBox="1"/>
          <p:nvPr/>
        </p:nvSpPr>
        <p:spPr>
          <a:xfrm>
            <a:off x="8928290" y="356663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4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7402245A-A7D8-4920-94D9-EB4635DA43E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259972" y="1968603"/>
            <a:ext cx="258141" cy="232889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F697CD32-C0CE-4778-8E08-E17538ACBA9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7237773" y="3937058"/>
            <a:ext cx="722480" cy="333085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3188257C-379E-4864-A428-598180ADDF6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7208892" y="2595213"/>
            <a:ext cx="311385" cy="296331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2F7B81EE-D316-4201-AAB8-3B59D420F71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7183833" y="2259003"/>
            <a:ext cx="311385" cy="280948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BC6B4DAD-24A1-4AF4-AFE6-8FB1C2FEDD0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259972" y="2949875"/>
            <a:ext cx="258141" cy="23288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B8A9BDAB-31CD-4B87-B015-C30863A2124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210430" y="4355927"/>
            <a:ext cx="326693" cy="232889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AD952BC3-7A9F-4602-8BD9-571A8862488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398882" y="1984778"/>
            <a:ext cx="518837" cy="232889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8BB24236-5456-42F7-8CB7-D5193BC0B6B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479669" y="4312745"/>
            <a:ext cx="467214" cy="232889"/>
          </a:xfrm>
          <a:prstGeom prst="rect">
            <a:avLst/>
          </a:prstGeom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6B1F95B6-9B71-46C0-B164-6C06ECA431DE}"/>
              </a:ext>
            </a:extLst>
          </p:cNvPr>
          <p:cNvSpPr/>
          <p:nvPr/>
        </p:nvSpPr>
        <p:spPr>
          <a:xfrm>
            <a:off x="7587309" y="3594842"/>
            <a:ext cx="372269" cy="111261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873703F-73D9-49D4-B671-5F90D247C861}"/>
              </a:ext>
            </a:extLst>
          </p:cNvPr>
          <p:cNvSpPr/>
          <p:nvPr/>
        </p:nvSpPr>
        <p:spPr>
          <a:xfrm>
            <a:off x="7187836" y="3596855"/>
            <a:ext cx="372269" cy="1110606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AB8D45D6-9F81-45EE-920C-B3165536E58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7276018" y="2611170"/>
            <a:ext cx="633892" cy="271893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02CE42C7-2FB8-4969-B17F-370E9121869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7242294" y="2297391"/>
            <a:ext cx="667616" cy="248169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24BFE774-4C2A-446A-ACAF-DCCE25CA7F5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7426291" y="2952497"/>
            <a:ext cx="483619" cy="23288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91B2DBD-88CC-40F5-BDA3-690409F04816}"/>
              </a:ext>
            </a:extLst>
          </p:cNvPr>
          <p:cNvSpPr/>
          <p:nvPr/>
        </p:nvSpPr>
        <p:spPr>
          <a:xfrm>
            <a:off x="7169435" y="1535769"/>
            <a:ext cx="372269" cy="1749156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ADA22F9-D3E9-48B6-9D5F-5D46C6046190}"/>
              </a:ext>
            </a:extLst>
          </p:cNvPr>
          <p:cNvSpPr/>
          <p:nvPr/>
        </p:nvSpPr>
        <p:spPr>
          <a:xfrm>
            <a:off x="7564145" y="1535769"/>
            <a:ext cx="372269" cy="1749156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0E5C1075-13D4-44E0-A8D1-42D8708B9B7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8192965" y="4377679"/>
            <a:ext cx="331321" cy="232889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089ADA9C-D377-41C5-8873-8011CB263DE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8148699" y="2229519"/>
            <a:ext cx="455035" cy="333085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114D507C-3465-47A8-A5C3-0FAC2E999A7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8166308" y="3963615"/>
            <a:ext cx="357978" cy="23289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4AF85301-5469-497B-9683-E8C87B53D6D0}"/>
              </a:ext>
            </a:extLst>
          </p:cNvPr>
          <p:cNvSpPr txBox="1"/>
          <p:nvPr/>
        </p:nvSpPr>
        <p:spPr>
          <a:xfrm>
            <a:off x="8148699" y="357822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3</a:t>
            </a: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C2C75683-7AE7-42AC-BEAA-C17885176C1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3106" r="77669" b="36332"/>
          <a:stretch/>
        </p:blipFill>
        <p:spPr>
          <a:xfrm>
            <a:off x="8158931" y="2638315"/>
            <a:ext cx="434068" cy="253229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AA2862CC-6131-43C3-9D75-8F78A87DEEB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8166308" y="2950014"/>
            <a:ext cx="426692" cy="232889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1EE1715C-D6C1-4C34-9CB0-4A889BA8AD4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9583" r="77669"/>
          <a:stretch/>
        </p:blipFill>
        <p:spPr>
          <a:xfrm>
            <a:off x="8158931" y="1972995"/>
            <a:ext cx="435590" cy="232889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327B25E7-90F3-42C0-8DE3-58C045039D83}"/>
              </a:ext>
            </a:extLst>
          </p:cNvPr>
          <p:cNvSpPr/>
          <p:nvPr/>
        </p:nvSpPr>
        <p:spPr>
          <a:xfrm>
            <a:off x="8220730" y="1536736"/>
            <a:ext cx="372269" cy="174818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DC6E3F6-EAC3-4121-AA46-04CAD7F2A8CC}"/>
              </a:ext>
            </a:extLst>
          </p:cNvPr>
          <p:cNvSpPr txBox="1"/>
          <p:nvPr/>
        </p:nvSpPr>
        <p:spPr>
          <a:xfrm>
            <a:off x="7163021" y="1968352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739C1B2-BDC3-474B-BCF1-778D3F0D4F7A}"/>
              </a:ext>
            </a:extLst>
          </p:cNvPr>
          <p:cNvSpPr txBox="1"/>
          <p:nvPr/>
        </p:nvSpPr>
        <p:spPr>
          <a:xfrm>
            <a:off x="7176529" y="2272950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1E5F1D9-1815-45EA-A7DB-659F9BF7EEC7}"/>
              </a:ext>
            </a:extLst>
          </p:cNvPr>
          <p:cNvSpPr txBox="1"/>
          <p:nvPr/>
        </p:nvSpPr>
        <p:spPr>
          <a:xfrm>
            <a:off x="7169359" y="2604706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94257D6-90D0-41C5-A4DE-E2E427002F4A}"/>
              </a:ext>
            </a:extLst>
          </p:cNvPr>
          <p:cNvSpPr txBox="1"/>
          <p:nvPr/>
        </p:nvSpPr>
        <p:spPr>
          <a:xfrm>
            <a:off x="7163021" y="2952746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9E0EE79-124A-4B2C-A5EA-C28DEC35F54E}"/>
              </a:ext>
            </a:extLst>
          </p:cNvPr>
          <p:cNvSpPr txBox="1"/>
          <p:nvPr/>
        </p:nvSpPr>
        <p:spPr>
          <a:xfrm>
            <a:off x="7175539" y="3987294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6274B57-AE84-4F08-B8CC-C23CB10A1054}"/>
              </a:ext>
            </a:extLst>
          </p:cNvPr>
          <p:cNvSpPr txBox="1"/>
          <p:nvPr/>
        </p:nvSpPr>
        <p:spPr>
          <a:xfrm>
            <a:off x="7181726" y="4334421"/>
            <a:ext cx="793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B01E68-CF66-442D-A981-CCADA71BCB00}"/>
              </a:ext>
            </a:extLst>
          </p:cNvPr>
          <p:cNvSpPr txBox="1"/>
          <p:nvPr/>
        </p:nvSpPr>
        <p:spPr>
          <a:xfrm>
            <a:off x="906229" y="1661651"/>
            <a:ext cx="1521752" cy="13849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200" u="sng" dirty="0"/>
              <a:t>Crop rotation scheme</a:t>
            </a:r>
          </a:p>
          <a:p>
            <a:r>
              <a:rPr lang="en-GB" sz="1200" dirty="0"/>
              <a:t>1 – Potato</a:t>
            </a:r>
          </a:p>
          <a:p>
            <a:r>
              <a:rPr lang="en-GB" sz="1200" b="1" dirty="0"/>
              <a:t>2 – Pea</a:t>
            </a:r>
          </a:p>
          <a:p>
            <a:r>
              <a:rPr lang="en-GB" sz="1200" dirty="0"/>
              <a:t>3 – Leek</a:t>
            </a:r>
          </a:p>
          <a:p>
            <a:r>
              <a:rPr lang="en-GB" sz="1200" dirty="0"/>
              <a:t>4 – Summer barley </a:t>
            </a:r>
          </a:p>
          <a:p>
            <a:r>
              <a:rPr lang="en-GB" sz="1200" dirty="0"/>
              <a:t>5 – Sugar beet</a:t>
            </a:r>
          </a:p>
          <a:p>
            <a:r>
              <a:rPr lang="en-GB" sz="1200" dirty="0"/>
              <a:t>6 – Maize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8957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09E53-76CC-48CD-BBDA-9235E35E0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9148" y="111519"/>
            <a:ext cx="10515600" cy="415255"/>
          </a:xfrm>
        </p:spPr>
        <p:txBody>
          <a:bodyPr>
            <a:normAutofit/>
          </a:bodyPr>
          <a:lstStyle/>
          <a:p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2.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per treatment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OTU_11 - family </a:t>
            </a:r>
            <a:r>
              <a:rPr lang="nl-NL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rbiliaceae</a:t>
            </a:r>
            <a:r>
              <a:rPr lang="nl-NL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9B8E96C7-0414-4FAF-A7B9-F3C2DAADC9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r="8624"/>
          <a:stretch/>
        </p:blipFill>
        <p:spPr>
          <a:xfrm>
            <a:off x="664177" y="897622"/>
            <a:ext cx="6021850" cy="4663718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6E2DC41F-33A9-4660-9B30-B495011106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91375" t="42991" b="45722"/>
          <a:stretch/>
        </p:blipFill>
        <p:spPr>
          <a:xfrm>
            <a:off x="6769916" y="782374"/>
            <a:ext cx="1549059" cy="14345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8879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0ACF3D73-2255-4C45-8413-55E4D5640F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22086" y="316320"/>
            <a:ext cx="5638384" cy="6414515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9E7CABF3-299E-4F47-A6B1-76B9BC32AA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163210" y="273590"/>
            <a:ext cx="5176521" cy="6552631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2B193829-7505-4E48-91A4-6FC982B7A94B}"/>
              </a:ext>
            </a:extLst>
          </p:cNvPr>
          <p:cNvSpPr txBox="1">
            <a:spLocks/>
          </p:cNvSpPr>
          <p:nvPr/>
        </p:nvSpPr>
        <p:spPr>
          <a:xfrm>
            <a:off x="-2216883" y="-158757"/>
            <a:ext cx="10515600" cy="41525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Ef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er soil management type for DNA-bulk and RNA-bulk .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192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BC6DE8BA-0927-1247-B341-0B492EC2F077}"/>
              </a:ext>
            </a:extLst>
          </p:cNvPr>
          <p:cNvSpPr txBox="1">
            <a:spLocks/>
          </p:cNvSpPr>
          <p:nvPr/>
        </p:nvSpPr>
        <p:spPr>
          <a:xfrm>
            <a:off x="127000" y="0"/>
            <a:ext cx="6248401" cy="41525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Nematode communities under various soil management regimes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CA6619E-686A-4363-A769-C9C0ADBD1D28}"/>
              </a:ext>
            </a:extLst>
          </p:cNvPr>
          <p:cNvSpPr txBox="1"/>
          <p:nvPr/>
        </p:nvSpPr>
        <p:spPr>
          <a:xfrm>
            <a:off x="1971413" y="5821960"/>
            <a:ext cx="511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E4B6BA1-BD93-4888-B253-49E5E3512D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764" y="1074994"/>
            <a:ext cx="11399235" cy="4401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30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136</Words>
  <Application>Microsoft Office PowerPoint</Application>
  <PresentationFormat>Widescreen</PresentationFormat>
  <Paragraphs>3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ody)</vt:lpstr>
      <vt:lpstr>Calibri</vt:lpstr>
      <vt:lpstr>Calibri Light</vt:lpstr>
      <vt:lpstr>Office Theme</vt:lpstr>
      <vt:lpstr>PowerPoint Presentation</vt:lpstr>
      <vt:lpstr>Supplementary figure 2. Abundance per treatment for OTU_11 - family Orbiliaceae. 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Harkes</dc:creator>
  <cp:lastModifiedBy>Paula Harkes</cp:lastModifiedBy>
  <cp:revision>18</cp:revision>
  <dcterms:created xsi:type="dcterms:W3CDTF">2019-09-18T07:15:59Z</dcterms:created>
  <dcterms:modified xsi:type="dcterms:W3CDTF">2019-11-04T13:50:28Z</dcterms:modified>
</cp:coreProperties>
</file>